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avid Peris" initials="DP" lastIdx="1" clrIdx="0">
    <p:extLst>
      <p:ext uri="{19B8F6BF-5375-455C-9EA6-DF929625EA0E}">
        <p15:presenceInfo xmlns:p15="http://schemas.microsoft.com/office/powerpoint/2012/main" userId="a2691e3ea15f920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4B6F1"/>
    <a:srgbClr val="55FFFF"/>
    <a:srgbClr val="CC6600"/>
    <a:srgbClr val="FF00FF"/>
    <a:srgbClr val="E1BC8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85381" autoAdjust="0"/>
  </p:normalViewPr>
  <p:slideViewPr>
    <p:cSldViewPr snapToGrid="0">
      <p:cViewPr varScale="1">
        <p:scale>
          <a:sx n="67" d="100"/>
          <a:sy n="67" d="100"/>
        </p:scale>
        <p:origin x="557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CEA2AD-2B61-4BAF-BEF3-48954D0FCE95}" type="datetimeFigureOut">
              <a:rPr lang="en-US" smtClean="0"/>
              <a:t>2/13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778169-7242-44CF-8050-B97CB7E693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38628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2778169-7242-44CF-8050-B97CB7E6938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2272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93BBB-AA71-4DB0-8C5F-85F9BE2C407A}" type="datetimeFigureOut">
              <a:rPr lang="en-US" smtClean="0"/>
              <a:t>2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96C08-2FA2-4CC0-B515-0A3ACB629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54377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93BBB-AA71-4DB0-8C5F-85F9BE2C407A}" type="datetimeFigureOut">
              <a:rPr lang="en-US" smtClean="0"/>
              <a:t>2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96C08-2FA2-4CC0-B515-0A3ACB629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34377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93BBB-AA71-4DB0-8C5F-85F9BE2C407A}" type="datetimeFigureOut">
              <a:rPr lang="en-US" smtClean="0"/>
              <a:t>2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96C08-2FA2-4CC0-B515-0A3ACB629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0739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93BBB-AA71-4DB0-8C5F-85F9BE2C407A}" type="datetimeFigureOut">
              <a:rPr lang="en-US" smtClean="0"/>
              <a:t>2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96C08-2FA2-4CC0-B515-0A3ACB629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65540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93BBB-AA71-4DB0-8C5F-85F9BE2C407A}" type="datetimeFigureOut">
              <a:rPr lang="en-US" smtClean="0"/>
              <a:t>2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96C08-2FA2-4CC0-B515-0A3ACB629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95326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93BBB-AA71-4DB0-8C5F-85F9BE2C407A}" type="datetimeFigureOut">
              <a:rPr lang="en-US" smtClean="0"/>
              <a:t>2/1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96C08-2FA2-4CC0-B515-0A3ACB629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26780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93BBB-AA71-4DB0-8C5F-85F9BE2C407A}" type="datetimeFigureOut">
              <a:rPr lang="en-US" smtClean="0"/>
              <a:t>2/13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96C08-2FA2-4CC0-B515-0A3ACB629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58652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93BBB-AA71-4DB0-8C5F-85F9BE2C407A}" type="datetimeFigureOut">
              <a:rPr lang="en-US" smtClean="0"/>
              <a:t>2/13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96C08-2FA2-4CC0-B515-0A3ACB629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91657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93BBB-AA71-4DB0-8C5F-85F9BE2C407A}" type="datetimeFigureOut">
              <a:rPr lang="en-US" smtClean="0"/>
              <a:t>2/13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96C08-2FA2-4CC0-B515-0A3ACB629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66401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93BBB-AA71-4DB0-8C5F-85F9BE2C407A}" type="datetimeFigureOut">
              <a:rPr lang="en-US" smtClean="0"/>
              <a:t>2/1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96C08-2FA2-4CC0-B515-0A3ACB629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79690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93BBB-AA71-4DB0-8C5F-85F9BE2C407A}" type="datetimeFigureOut">
              <a:rPr lang="en-US" smtClean="0"/>
              <a:t>2/1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96C08-2FA2-4CC0-B515-0A3ACB629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3390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E93BBB-AA71-4DB0-8C5F-85F9BE2C407A}" type="datetimeFigureOut">
              <a:rPr lang="en-US" smtClean="0"/>
              <a:t>2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A96C08-2FA2-4CC0-B515-0A3ACB629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60813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962825" y="302854"/>
            <a:ext cx="2578608" cy="1911096"/>
          </a:xfrm>
          <a:prstGeom prst="rect">
            <a:avLst/>
          </a:prstGeom>
        </p:spPr>
      </p:pic>
      <p:pic>
        <p:nvPicPr>
          <p:cNvPr id="5" name="Picture 4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5005088" y="1148960"/>
            <a:ext cx="2578608" cy="1911096"/>
          </a:xfrm>
          <a:prstGeom prst="rect">
            <a:avLst/>
          </a:prstGeom>
        </p:spPr>
      </p:pic>
      <p:pic>
        <p:nvPicPr>
          <p:cNvPr id="6" name="Picture 5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963191" y="2516063"/>
            <a:ext cx="2578608" cy="1911096"/>
          </a:xfrm>
          <a:prstGeom prst="rect">
            <a:avLst/>
          </a:prstGeom>
        </p:spPr>
      </p:pic>
      <p:pic>
        <p:nvPicPr>
          <p:cNvPr id="7" name="Picture 6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5016518" y="3480373"/>
            <a:ext cx="2578608" cy="1911096"/>
          </a:xfrm>
          <a:prstGeom prst="rect">
            <a:avLst/>
          </a:prstGeom>
        </p:spPr>
      </p:pic>
      <p:pic>
        <p:nvPicPr>
          <p:cNvPr id="8" name="Picture 7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951114" y="4636466"/>
            <a:ext cx="2642616" cy="1911096"/>
          </a:xfrm>
          <a:prstGeom prst="rect">
            <a:avLst/>
          </a:prstGeom>
        </p:spPr>
      </p:pic>
      <p:sp>
        <p:nvSpPr>
          <p:cNvPr id="65" name="TextBox 64"/>
          <p:cNvSpPr txBox="1"/>
          <p:nvPr/>
        </p:nvSpPr>
        <p:spPr>
          <a:xfrm>
            <a:off x="1821577" y="98355"/>
            <a:ext cx="10310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-xylose (g/L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1857777" y="2316570"/>
            <a:ext cx="10086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lycerol (g/L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1981547" y="4540809"/>
            <a:ext cx="7168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iomass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740387" y="633586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977215" y="652654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1312519" y="652762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1651597" y="652429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1988769" y="652429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2327423" y="652907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2631702" y="652656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3296877" y="652777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2970540" y="652424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1877091" y="6621894"/>
            <a:ext cx="8611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ime (days)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5046793" y="538843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5378287" y="538951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5697553" y="539189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6030407" y="539189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6361441" y="538905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6663815" y="539036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7312570" y="539156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6990588" y="539184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5900390" y="5526876"/>
            <a:ext cx="8611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ime (days)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5918823" y="770904"/>
            <a:ext cx="8819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Xylitol (g/L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7514245" y="5839753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CSH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7496985" y="6030616"/>
            <a:ext cx="11875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YPDX + HTs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7505199" y="6228278"/>
            <a:ext cx="10981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YPDX + F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7517899" y="6431478"/>
            <a:ext cx="6751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YPDX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5873938" y="3294027"/>
            <a:ext cx="9685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thanol (g/L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81388" y="60079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9" name="TextBox 98"/>
          <p:cNvSpPr txBox="1"/>
          <p:nvPr/>
        </p:nvSpPr>
        <p:spPr>
          <a:xfrm>
            <a:off x="79617" y="2161021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87711" y="4430204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01" name="TextBox 100"/>
          <p:cNvSpPr txBox="1"/>
          <p:nvPr/>
        </p:nvSpPr>
        <p:spPr>
          <a:xfrm>
            <a:off x="690192" y="71901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686967" y="123420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692078" y="174958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745910" y="345317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745910" y="384087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745910" y="423053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742903" y="305923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745910" y="267250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685753" y="507506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682167" y="570773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4319549" y="827412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2" name="TextBox 111"/>
          <p:cNvSpPr txBox="1"/>
          <p:nvPr/>
        </p:nvSpPr>
        <p:spPr>
          <a:xfrm>
            <a:off x="4317778" y="3102525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13" name="TextBox 112"/>
          <p:cNvSpPr txBox="1"/>
          <p:nvPr/>
        </p:nvSpPr>
        <p:spPr>
          <a:xfrm>
            <a:off x="4783277" y="160876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4785406" y="215961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4783277" y="271974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4786095" y="104745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18" name="TextBox 117"/>
          <p:cNvSpPr txBox="1"/>
          <p:nvPr/>
        </p:nvSpPr>
        <p:spPr>
          <a:xfrm>
            <a:off x="4748616" y="358000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4750745" y="411091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4748616" y="464501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4806324" y="517326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981025" y="441278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1306804" y="441385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1636357" y="441052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1965909" y="441052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2295038" y="441530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2591697" y="441280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3237822" y="441020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2921010" y="441047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983813" y="219835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1315307" y="219942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1640415" y="219609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1969332" y="219609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2297826" y="220341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2595755" y="219837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3245690" y="219576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2925068" y="219604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5027819" y="304177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5355503" y="304285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5688866" y="303951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6016513" y="303951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6341832" y="304430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6644206" y="304179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7297951" y="303919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6973698" y="304941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1" name="Picture 140"/>
          <p:cNvPicPr>
            <a:picLocks noChangeAspect="1"/>
          </p:cNvPicPr>
          <p:nvPr/>
        </p:nvPicPr>
        <p:blipFill rotWithShape="1">
          <a:blip r:embed="rId8"/>
          <a:srcRect l="4103" t="24991" r="61364"/>
          <a:stretch/>
        </p:blipFill>
        <p:spPr>
          <a:xfrm>
            <a:off x="7290811" y="5939285"/>
            <a:ext cx="231648" cy="7576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27591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9</TotalTime>
  <Words>98</Words>
  <Application>Microsoft Office PowerPoint</Application>
  <PresentationFormat>On-screen Show (4:3)</PresentationFormat>
  <Paragraphs>7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VE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Peris</dc:creator>
  <cp:lastModifiedBy>David Peris</cp:lastModifiedBy>
  <cp:revision>76</cp:revision>
  <cp:lastPrinted>2016-06-04T00:59:54Z</cp:lastPrinted>
  <dcterms:created xsi:type="dcterms:W3CDTF">2015-12-07T20:38:26Z</dcterms:created>
  <dcterms:modified xsi:type="dcterms:W3CDTF">2017-02-13T19:56:23Z</dcterms:modified>
</cp:coreProperties>
</file>